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99" d="100"/>
          <a:sy n="99" d="100"/>
        </p:scale>
        <p:origin x="103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149DF8-AEA9-0B9C-9CCD-112D30E68B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C8795AF-E121-AAA0-8632-C5A2BD9DC4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05CF00-8DF0-91A0-F1EB-C7BCBE84F3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50F5D7-D297-CADE-13F7-396C289F2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02A622-CBA1-9518-88AA-FC40A8C466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3306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F07E66-2809-2621-F789-80750518A4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98B2835-8B67-23A2-513A-D3777B4757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D4A5B8-3E5C-0648-DC75-164D2417AD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A94DF8-F88C-7D8C-722E-A247278853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9F9CD7-3740-D0DE-0090-D4964F16B5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78979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5E70A65-0427-1B92-002A-4F0130E6E5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19B96AF-E333-EAA1-39E8-4C9EFC578A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8A7142-16B9-34B8-AA27-8F6E15C4B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588E10-F194-FE1F-F476-BE597D1687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EB1810-4B2C-CA9E-E356-9E1D3718F9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61638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D54E3A-6EAC-67E4-98DF-80276FA37F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A7486D-196C-1E00-7FB3-2375C5CBF5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438DA8-840A-A998-1115-3F0076F58F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9F8F09-B7AB-16FE-4936-9589B01A7B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07DBB4-3DC1-F01B-1071-72281A645C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364009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1E2EC3-EDDF-F60A-1A61-D519D6AD34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EB5F3E-A9E2-269B-F180-8F961E0FFD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086041-4FCF-97AC-069B-B54D012F50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DB68CC-1E71-E146-376B-67E2C57298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FB8B22-2FA3-D1FC-1A78-FF382D25F4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414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BE49BB-5488-A539-1946-28160C1266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FA10D4-A6B5-616B-5559-072104D7258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26A7ED-D6FD-3870-C415-A10D52077F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48439B-EC26-E8F0-AAC4-76F73BE59C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A574A9-D518-075E-D885-BC4B373A06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2BF93D-254C-C175-F46A-56C61D544B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3682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7F0A3B-C403-11E8-E00E-0D3A305A0E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9D3553-32A6-DEAB-09E2-037F159CC2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8ADD45-48AB-B746-565E-1E378E07FF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9807B74-94C2-0BED-BA71-A230411432B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D934FF6-FAEC-689B-E6F3-3949345AF6A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9451FD6-200F-3CC2-4A92-208ACE9E6D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C2CEBF6-D6A0-69A5-0567-21DC492985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2459039-02D2-1D74-E6CC-81EB09A0B1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20377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CD2D99-1B9D-AE96-B82A-96B282C57E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E671548-F426-19AC-D6EE-9EF00F3767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4339605-41C0-BF21-88C9-62DA52C304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D3D0A9A-27EE-8E87-6D01-BCCDA35E22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20112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8DCC719-9107-383B-4C05-AA29E6E65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89EC36E-3F1F-8A50-1A45-C8AADCCD6D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D6AC2B5-6E26-F1C8-A980-C545BAC4C8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980497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2EEF6A-32C3-5281-6E01-ABC51F889D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B61EBF-8C15-DCCD-BC66-3E499B1820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A19888-E0B0-BED3-A4EA-F7B970ECB7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C0CF7F-C029-0B63-E917-8F6DA0C590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8E2E5F-B921-313F-4BD6-CB29E72143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4B7607-C6AF-0E88-C961-88A8C8C653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668091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B07FA8-65D9-3688-44AF-75C4CE03E2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7372209-70B5-B736-170B-0332391127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052824-193D-F88B-8E6D-E64B483B37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DE000B0-4191-5D12-B885-0AECB932EC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F812D4-A368-D18C-D52E-0A2F8D3DC6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0D4EC7-9AD1-29EA-6E3A-44437CD7A4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445029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7B1ADEA-A961-3FD6-F792-34ED2E4A45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C4865F-C364-783F-1202-EDA39809E4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74FF10-CC9B-619B-DF96-63A3CAAC063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D714BE-B2BF-F488-ABAB-8E435BAC919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F2B16C-0637-8BCD-495D-64B61F3E026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568710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157D1A2D-E2ED-0135-04A9-B392DD3682B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9651947"/>
              </p:ext>
            </p:extLst>
          </p:nvPr>
        </p:nvGraphicFramePr>
        <p:xfrm>
          <a:off x="1588654" y="593238"/>
          <a:ext cx="9014691" cy="489566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80101">
                  <a:extLst>
                    <a:ext uri="{9D8B030D-6E8A-4147-A177-3AD203B41FA5}">
                      <a16:colId xmlns:a16="http://schemas.microsoft.com/office/drawing/2014/main" val="1387641416"/>
                    </a:ext>
                  </a:extLst>
                </a:gridCol>
                <a:gridCol w="1329355">
                  <a:extLst>
                    <a:ext uri="{9D8B030D-6E8A-4147-A177-3AD203B41FA5}">
                      <a16:colId xmlns:a16="http://schemas.microsoft.com/office/drawing/2014/main" val="3961484200"/>
                    </a:ext>
                  </a:extLst>
                </a:gridCol>
                <a:gridCol w="6605235">
                  <a:extLst>
                    <a:ext uri="{9D8B030D-6E8A-4147-A177-3AD203B41FA5}">
                      <a16:colId xmlns:a16="http://schemas.microsoft.com/office/drawing/2014/main" val="2135804294"/>
                    </a:ext>
                  </a:extLst>
                </a:gridCol>
              </a:tblGrid>
              <a:tr h="367678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Library code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tx1"/>
                          </a:solidFill>
                          <a:effectLst/>
                        </a:rPr>
                        <a:t>Range of entries 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Sources (Paper Titles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3122720"/>
                  </a:ext>
                </a:extLst>
              </a:tr>
              <a:tr h="567891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LDCO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-43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Lead discovery, chemical optimization, and biological evaluation studies of novel histone methyltransferase SET7 small-molecule inhibitors (Hou et al., 2020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36725962"/>
                  </a:ext>
                </a:extLst>
              </a:tr>
              <a:tr h="564206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BP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44-111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Using ‘biased-privileged’ scaffolds to identify lysine methyltransferase inhibitors Sudhir Kashyap </a:t>
                      </a:r>
                      <a:r>
                        <a:rPr lang="en-US" sz="1400" dirty="0" err="1">
                          <a:effectLst/>
                        </a:rPr>
                        <a:t>a,b,a</a:t>
                      </a:r>
                      <a:r>
                        <a:rPr lang="en-US" sz="1400" dirty="0">
                          <a:effectLst/>
                        </a:rPr>
                        <a:t> (Kashyap et al., 2014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01009523"/>
                  </a:ext>
                </a:extLst>
              </a:tr>
              <a:tr h="314481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RPFI2ANA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11-141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Structure–Activity Relationship Studies on (R)-PFI-2 Analogues as Inhibitors of Histone Lysine Methyltransferase SETD7 (</a:t>
                      </a:r>
                      <a:r>
                        <a:rPr lang="en-US" sz="1400" dirty="0" err="1">
                          <a:effectLst/>
                        </a:rPr>
                        <a:t>Lenstra</a:t>
                      </a:r>
                      <a:r>
                        <a:rPr lang="en-US" sz="1400" dirty="0">
                          <a:effectLst/>
                        </a:rPr>
                        <a:t> et al., 2018) 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91424294"/>
                  </a:ext>
                </a:extLst>
              </a:tr>
              <a:tr h="564206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CYPRO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42-199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Development of novel inhibitors for histone methyltransferase SET7/9 based on cyproheptadine (Hirano et al., 2018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366406"/>
                  </a:ext>
                </a:extLst>
              </a:tr>
              <a:tr h="564206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CTFO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200 -205 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Cancer treatment of the future: Inhibitors of histone methyltransferases,∗(Monteiro et al., 2022; </a:t>
                      </a:r>
                      <a:r>
                        <a:rPr lang="en-US" sz="1400" err="1">
                          <a:effectLst/>
                        </a:rPr>
                        <a:t>Spannhoff</a:t>
                      </a:r>
                      <a:r>
                        <a:rPr lang="en-US" sz="1400">
                          <a:effectLst/>
                        </a:rPr>
                        <a:t> et al., 2009; Zhou et al., 2009)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97089767"/>
                  </a:ext>
                </a:extLst>
              </a:tr>
              <a:tr h="643309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DSCO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05 -462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Discovery and optimization of novel, selective histone methyltransferase SET7 inhibitors by pharmacophore- and docking-based virtual screening F (Meng et al., 2015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64371075"/>
                  </a:ext>
                </a:extLst>
              </a:tr>
              <a:tr h="172314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BDDB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463-470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Binding Database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918140"/>
                  </a:ext>
                </a:extLst>
              </a:tr>
              <a:tr h="13288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DGBK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471-473 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err="1">
                          <a:effectLst/>
                        </a:rPr>
                        <a:t>Drugbank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18224870"/>
                  </a:ext>
                </a:extLst>
              </a:tr>
              <a:tr h="132882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CHEMBL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474-585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err="1">
                          <a:effectLst/>
                        </a:rPr>
                        <a:t>Chembl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</a:endParaRPr>
                    </a:p>
                  </a:txBody>
                  <a:tcPr marL="45719" marR="45719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13022487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3F892C20-21AD-2683-9B31-4FC0F20423EA}"/>
              </a:ext>
            </a:extLst>
          </p:cNvPr>
          <p:cNvSpPr txBox="1"/>
          <p:nvPr/>
        </p:nvSpPr>
        <p:spPr>
          <a:xfrm>
            <a:off x="1468581" y="5691836"/>
            <a:ext cx="9550401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6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1:  </a:t>
            </a:r>
            <a:r>
              <a:rPr lang="en-IN" sz="16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library code for the </a:t>
            </a:r>
            <a:r>
              <a:rPr lang="en-US" sz="16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blished research articles and databases used to label the 585 inhibitors as alphanumeric code. </a:t>
            </a:r>
            <a:endParaRPr lang="en-IN" sz="1600" dirty="0"/>
          </a:p>
        </p:txBody>
      </p:sp>
    </p:spTree>
    <p:extLst>
      <p:ext uri="{BB962C8B-B14F-4D97-AF65-F5344CB8AC3E}">
        <p14:creationId xmlns:p14="http://schemas.microsoft.com/office/powerpoint/2010/main" val="5442439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7</Words>
  <Application>Microsoft Office PowerPoint</Application>
  <PresentationFormat>Widescreen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khil Gadewal</dc:creator>
  <cp:lastModifiedBy>Nikhil Gadewal</cp:lastModifiedBy>
  <cp:revision>2</cp:revision>
  <dcterms:created xsi:type="dcterms:W3CDTF">2024-06-03T09:21:54Z</dcterms:created>
  <dcterms:modified xsi:type="dcterms:W3CDTF">2024-06-03T09:22:32Z</dcterms:modified>
</cp:coreProperties>
</file>